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34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27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1935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540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946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7446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202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4653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8192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38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269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3033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EE35D-B1F9-448A-A520-B1E7355517FF}" type="datetimeFigureOut">
              <a:rPr lang="zh-CN" altLang="en-US" smtClean="0"/>
              <a:t>2023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A6DD12-1378-4762-959F-F3B51B2114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5726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639763" y="1596232"/>
            <a:ext cx="10454930" cy="3001962"/>
            <a:chOff x="639763" y="1596232"/>
            <a:chExt cx="10454930" cy="3001962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3"/>
            <a:srcRect b="15366"/>
            <a:stretch/>
          </p:blipFill>
          <p:spPr>
            <a:xfrm>
              <a:off x="9785978" y="3475141"/>
              <a:ext cx="1296015" cy="1096859"/>
            </a:xfrm>
            <a:prstGeom prst="rect">
              <a:avLst/>
            </a:prstGeom>
          </p:spPr>
        </p:pic>
        <p:graphicFrame>
          <p:nvGraphicFramePr>
            <p:cNvPr id="13" name="对象 12"/>
            <p:cNvGraphicFramePr>
              <a:graphicFrameLocks noChangeAspect="1"/>
            </p:cNvGraphicFramePr>
            <p:nvPr>
              <p:extLst/>
            </p:nvPr>
          </p:nvGraphicFramePr>
          <p:xfrm>
            <a:off x="639763" y="1596232"/>
            <a:ext cx="10454930" cy="3001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CS ChemDraw Drawing" r:id="rId4" imgW="6391343" imgH="1834461" progId="ChemDraw.Document.6.0">
                    <p:embed/>
                  </p:oleObj>
                </mc:Choice>
                <mc:Fallback>
                  <p:oleObj name="CS ChemDraw Drawing" r:id="rId4" imgW="6391343" imgH="1834461" progId="ChemDraw.Document.6.0">
                    <p:embed/>
                    <p:pic>
                      <p:nvPicPr>
                        <p:cNvPr id="13" name="对象 12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39763" y="1596232"/>
                          <a:ext cx="10454930" cy="30019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椭圆 1"/>
            <p:cNvSpPr/>
            <p:nvPr/>
          </p:nvSpPr>
          <p:spPr>
            <a:xfrm>
              <a:off x="2065468" y="4270786"/>
              <a:ext cx="720763" cy="24742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639763" y="1596232"/>
              <a:ext cx="66697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27440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1165218" y="633087"/>
            <a:ext cx="9892725" cy="5218417"/>
            <a:chOff x="1165218" y="633087"/>
            <a:chExt cx="9892725" cy="5218417"/>
          </a:xfrm>
        </p:grpSpPr>
        <p:grpSp>
          <p:nvGrpSpPr>
            <p:cNvPr id="9" name="组合 8"/>
            <p:cNvGrpSpPr/>
            <p:nvPr/>
          </p:nvGrpSpPr>
          <p:grpSpPr>
            <a:xfrm>
              <a:off x="1165218" y="633087"/>
              <a:ext cx="9892725" cy="5218417"/>
              <a:chOff x="1165218" y="633087"/>
              <a:chExt cx="9892725" cy="5218417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1165218" y="633087"/>
                <a:ext cx="9892725" cy="5218417"/>
                <a:chOff x="1165218" y="633087"/>
                <a:chExt cx="9892725" cy="5218417"/>
              </a:xfrm>
            </p:grpSpPr>
            <p:sp>
              <p:nvSpPr>
                <p:cNvPr id="100" name="文本框 99"/>
                <p:cNvSpPr txBox="1"/>
                <p:nvPr/>
              </p:nvSpPr>
              <p:spPr>
                <a:xfrm>
                  <a:off x="1165218" y="633087"/>
                  <a:ext cx="9892725" cy="5218417"/>
                </a:xfrm>
                <a:prstGeom prst="rect">
                  <a:avLst/>
                </a:prstGeom>
                <a:gradFill flip="none" rotWithShape="1">
                  <a:gsLst>
                    <a:gs pos="14000">
                      <a:srgbClr val="DECDFD"/>
                    </a:gs>
                    <a:gs pos="100000">
                      <a:schemeClr val="accent1">
                        <a:lumMod val="45000"/>
                        <a:lumOff val="55000"/>
                      </a:schemeClr>
                    </a:gs>
                    <a:gs pos="50000">
                      <a:schemeClr val="accent2">
                        <a:lumMod val="20000"/>
                        <a:lumOff val="80000"/>
                      </a:schemeClr>
                    </a:gs>
                    <a:gs pos="95000">
                      <a:schemeClr val="accent1">
                        <a:lumMod val="30000"/>
                        <a:lumOff val="70000"/>
                      </a:schemeClr>
                    </a:gs>
                  </a:gsLst>
                  <a:lin ang="5400000" scaled="1"/>
                  <a:tileRect/>
                </a:gradFill>
                <a:effectLst>
                  <a:outerShdw blurRad="50800" dist="50800" dir="5400000" algn="ctr" rotWithShape="0">
                    <a:srgbClr val="000000">
                      <a:alpha val="0"/>
                    </a:srgbClr>
                  </a:outerShdw>
                </a:effectLst>
              </p:spPr>
              <p:txBody>
                <a:bodyPr wrap="square" rtlCol="0">
                  <a:spAutoFit/>
                </a:bodyPr>
                <a:lstStyle/>
                <a:p>
                  <a:endParaRPr lang="zh-CN" altLang="en-US" dirty="0"/>
                </a:p>
              </p:txBody>
            </p:sp>
            <p:grpSp>
              <p:nvGrpSpPr>
                <p:cNvPr id="3" name="组合 2"/>
                <p:cNvGrpSpPr/>
                <p:nvPr/>
              </p:nvGrpSpPr>
              <p:grpSpPr>
                <a:xfrm>
                  <a:off x="1555099" y="1653191"/>
                  <a:ext cx="9177508" cy="3470153"/>
                  <a:chOff x="1592133" y="1438038"/>
                  <a:chExt cx="9177508" cy="3470153"/>
                </a:xfrm>
              </p:grpSpPr>
              <p:grpSp>
                <p:nvGrpSpPr>
                  <p:cNvPr id="4" name="组合 3"/>
                  <p:cNvGrpSpPr/>
                  <p:nvPr/>
                </p:nvGrpSpPr>
                <p:grpSpPr>
                  <a:xfrm>
                    <a:off x="7379746" y="1568935"/>
                    <a:ext cx="3389895" cy="2683044"/>
                    <a:chOff x="7541110" y="1458905"/>
                    <a:chExt cx="3389895" cy="2683044"/>
                  </a:xfrm>
                </p:grpSpPr>
                <p:pic>
                  <p:nvPicPr>
                    <p:cNvPr id="43" name="图片 42"/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8392" t="49961" r="28389" b="5134"/>
                    <a:stretch/>
                  </p:blipFill>
                  <p:spPr>
                    <a:xfrm>
                      <a:off x="7541110" y="1458905"/>
                      <a:ext cx="3389895" cy="2683044"/>
                    </a:xfrm>
                    <a:prstGeom prst="ellipse">
                      <a:avLst/>
                    </a:prstGeom>
                    <a:ln>
                      <a:noFill/>
                    </a:ln>
                    <a:effectLst>
                      <a:softEdge rad="112500"/>
                    </a:effectLst>
                  </p:spPr>
                </p:pic>
                <p:sp>
                  <p:nvSpPr>
                    <p:cNvPr id="44" name="文本框 43"/>
                    <p:cNvSpPr txBox="1"/>
                    <p:nvPr/>
                  </p:nvSpPr>
                  <p:spPr>
                    <a:xfrm>
                      <a:off x="8480081" y="2596402"/>
                      <a:ext cx="1511952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3200" b="1" dirty="0" smtClean="0">
                          <a:latin typeface="MV Boli" panose="02000500030200090000" pitchFamily="2" charset="0"/>
                          <a:cs typeface="MV Boli" panose="02000500030200090000" pitchFamily="2" charset="0"/>
                        </a:rPr>
                        <a:t>H-beta</a:t>
                      </a:r>
                      <a:endParaRPr lang="zh-CN" altLang="en-US" sz="3200" b="1" dirty="0">
                        <a:latin typeface="MV Boli" panose="02000500030200090000" pitchFamily="2" charset="0"/>
                        <a:cs typeface="MV Boli" panose="02000500030200090000" pitchFamily="2" charset="0"/>
                      </a:endParaRPr>
                    </a:p>
                  </p:txBody>
                </p:sp>
              </p:grpSp>
              <p:grpSp>
                <p:nvGrpSpPr>
                  <p:cNvPr id="5" name="组合 4"/>
                  <p:cNvGrpSpPr/>
                  <p:nvPr/>
                </p:nvGrpSpPr>
                <p:grpSpPr>
                  <a:xfrm>
                    <a:off x="1592133" y="1713334"/>
                    <a:ext cx="3302597" cy="2613949"/>
                    <a:chOff x="1592133" y="1713334"/>
                    <a:chExt cx="3302597" cy="2613949"/>
                  </a:xfrm>
                </p:grpSpPr>
                <p:pic>
                  <p:nvPicPr>
                    <p:cNvPr id="41" name="图片 40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1598" t="13961" r="22008" b="13725"/>
                    <a:stretch/>
                  </p:blipFill>
                  <p:spPr>
                    <a:xfrm>
                      <a:off x="1592133" y="1713334"/>
                      <a:ext cx="3302597" cy="2613949"/>
                    </a:xfrm>
                    <a:prstGeom prst="ellipse">
                      <a:avLst/>
                    </a:prstGeom>
                    <a:ln>
                      <a:noFill/>
                    </a:ln>
                    <a:effectLst>
                      <a:softEdge rad="112500"/>
                    </a:effectLst>
                  </p:spPr>
                </p:pic>
                <p:sp>
                  <p:nvSpPr>
                    <p:cNvPr id="42" name="文本框 41"/>
                    <p:cNvSpPr txBox="1"/>
                    <p:nvPr/>
                  </p:nvSpPr>
                  <p:spPr>
                    <a:xfrm>
                      <a:off x="2508294" y="2762468"/>
                      <a:ext cx="1470274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3200" b="1" dirty="0" smtClean="0">
                          <a:solidFill>
                            <a:schemeClr val="accent4">
                              <a:lumMod val="60000"/>
                              <a:lumOff val="40000"/>
                            </a:schemeClr>
                          </a:solidFill>
                          <a:latin typeface="MV Boli" panose="02000500030200090000" pitchFamily="2" charset="0"/>
                          <a:cs typeface="MV Boli" panose="02000500030200090000" pitchFamily="2" charset="0"/>
                        </a:rPr>
                        <a:t>InZrO</a:t>
                      </a:r>
                      <a:r>
                        <a:rPr lang="en-US" altLang="zh-CN" sz="3200" b="1" baseline="-25000" dirty="0" smtClean="0">
                          <a:solidFill>
                            <a:schemeClr val="accent4">
                              <a:lumMod val="60000"/>
                              <a:lumOff val="40000"/>
                            </a:schemeClr>
                          </a:solidFill>
                          <a:latin typeface="MV Boli" panose="02000500030200090000" pitchFamily="2" charset="0"/>
                          <a:cs typeface="MV Boli" panose="02000500030200090000" pitchFamily="2" charset="0"/>
                        </a:rPr>
                        <a:t>x</a:t>
                      </a:r>
                      <a:endParaRPr lang="zh-CN" altLang="en-US" sz="3200" b="1" baseline="-25000" dirty="0">
                        <a:solidFill>
                          <a:schemeClr val="accent4">
                            <a:lumMod val="60000"/>
                            <a:lumOff val="40000"/>
                          </a:schemeClr>
                        </a:solidFill>
                        <a:latin typeface="MV Boli" panose="02000500030200090000" pitchFamily="2" charset="0"/>
                        <a:cs typeface="MV Boli" panose="02000500030200090000" pitchFamily="2" charset="0"/>
                      </a:endParaRPr>
                    </a:p>
                  </p:txBody>
                </p:sp>
              </p:grpSp>
              <p:pic>
                <p:nvPicPr>
                  <p:cNvPr id="6" name="图片 5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rot="159053">
                    <a:off x="4637956" y="1875997"/>
                    <a:ext cx="2998565" cy="404597"/>
                  </a:xfrm>
                  <a:prstGeom prst="rect">
                    <a:avLst/>
                  </a:prstGeom>
                </p:spPr>
              </p:pic>
              <p:sp>
                <p:nvSpPr>
                  <p:cNvPr id="7" name="文本框 6"/>
                  <p:cNvSpPr txBox="1"/>
                  <p:nvPr/>
                </p:nvSpPr>
                <p:spPr>
                  <a:xfrm>
                    <a:off x="5056094" y="2900739"/>
                    <a:ext cx="2162287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H</a:t>
                    </a:r>
                    <a:r>
                      <a:rPr lang="en-US" altLang="zh-CN" sz="2000" baseline="-25000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2</a:t>
                    </a:r>
                    <a:r>
                      <a:rPr lang="en-US" altLang="zh-CN" sz="2000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 atmosphere</a:t>
                    </a:r>
                    <a:endParaRPr lang="zh-CN" altLang="en-US" sz="2000" dirty="0">
                      <a:latin typeface="MV Boli" panose="02000500030200090000" pitchFamily="2" charset="0"/>
                      <a:cs typeface="MV Boli" panose="02000500030200090000" pitchFamily="2" charset="0"/>
                    </a:endParaRPr>
                  </a:p>
                </p:txBody>
              </p:sp>
              <p:sp>
                <p:nvSpPr>
                  <p:cNvPr id="8" name="文本框 7"/>
                  <p:cNvSpPr txBox="1"/>
                  <p:nvPr/>
                </p:nvSpPr>
                <p:spPr>
                  <a:xfrm>
                    <a:off x="5014272" y="1438038"/>
                    <a:ext cx="3046104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Indium migration</a:t>
                    </a:r>
                    <a:endParaRPr lang="zh-CN" altLang="en-US" sz="2000" dirty="0">
                      <a:latin typeface="MV Boli" panose="02000500030200090000" pitchFamily="2" charset="0"/>
                      <a:cs typeface="MV Boli" panose="02000500030200090000" pitchFamily="2" charset="0"/>
                    </a:endParaRPr>
                  </a:p>
                </p:txBody>
              </p:sp>
              <p:pic>
                <p:nvPicPr>
                  <p:cNvPr id="13" name="图片 12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flipV="1">
                    <a:off x="4638928" y="3797119"/>
                    <a:ext cx="2968139" cy="445916"/>
                  </a:xfrm>
                  <a:prstGeom prst="rect">
                    <a:avLst/>
                  </a:prstGeom>
                </p:spPr>
              </p:pic>
              <p:sp>
                <p:nvSpPr>
                  <p:cNvPr id="32" name="文本框 31"/>
                  <p:cNvSpPr txBox="1"/>
                  <p:nvPr/>
                </p:nvSpPr>
                <p:spPr>
                  <a:xfrm>
                    <a:off x="3766022" y="3353616"/>
                    <a:ext cx="56410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600" dirty="0" smtClean="0">
                        <a:solidFill>
                          <a:schemeClr val="bg1"/>
                        </a:solidFill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In</a:t>
                    </a:r>
                    <a:endParaRPr lang="zh-CN" altLang="en-US" sz="1600" dirty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endParaRPr>
                  </a:p>
                </p:txBody>
              </p:sp>
              <p:sp>
                <p:nvSpPr>
                  <p:cNvPr id="27" name="椭圆 26"/>
                  <p:cNvSpPr/>
                  <p:nvPr/>
                </p:nvSpPr>
                <p:spPr>
                  <a:xfrm>
                    <a:off x="4637269" y="2420500"/>
                    <a:ext cx="206204" cy="218268"/>
                  </a:xfrm>
                  <a:prstGeom prst="ellipse">
                    <a:avLst/>
                  </a:prstGeom>
                  <a:solidFill>
                    <a:srgbClr val="99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" name="文本框 19"/>
                  <p:cNvSpPr txBox="1"/>
                  <p:nvPr/>
                </p:nvSpPr>
                <p:spPr>
                  <a:xfrm>
                    <a:off x="4867855" y="4508081"/>
                    <a:ext cx="2993611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 smtClean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limit</a:t>
                    </a:r>
                    <a:r>
                      <a:rPr lang="zh-CN" altLang="en-US" sz="2000" dirty="0" smtClean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 </a:t>
                    </a:r>
                    <a:r>
                      <a:rPr lang="en-US" altLang="zh-CN" sz="2000" dirty="0" smtClean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Indium </a:t>
                    </a:r>
                    <a:r>
                      <a:rPr lang="en-US" altLang="zh-CN" sz="2000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migration</a:t>
                    </a:r>
                    <a:endParaRPr lang="zh-CN" altLang="en-US" sz="2000" dirty="0">
                      <a:latin typeface="MV Boli" panose="02000500030200090000" pitchFamily="2" charset="0"/>
                      <a:cs typeface="MV Boli" panose="02000500030200090000" pitchFamily="2" charset="0"/>
                    </a:endParaRPr>
                  </a:p>
                </p:txBody>
              </p:sp>
              <p:sp>
                <p:nvSpPr>
                  <p:cNvPr id="21" name="cancel-mark_17124">
                    <a:extLst>
                      <a:ext uri="{FF2B5EF4-FFF2-40B4-BE49-F238E27FC236}">
                        <a16:creationId xmlns:a16="http://schemas.microsoft.com/office/drawing/2014/main" id="{54405246-CCE2-4201-BBB1-D3F3EB6E740D}"/>
                      </a:ext>
                    </a:extLst>
                  </p:cNvPr>
                  <p:cNvSpPr/>
                  <p:nvPr/>
                </p:nvSpPr>
                <p:spPr>
                  <a:xfrm>
                    <a:off x="5871383" y="3862483"/>
                    <a:ext cx="610649" cy="621759"/>
                  </a:xfrm>
                  <a:custGeom>
                    <a:avLst/>
                    <a:gdLst>
                      <a:gd name="T0" fmla="*/ 127 w 3392"/>
                      <a:gd name="T1" fmla="*/ 2898 h 3392"/>
                      <a:gd name="T2" fmla="*/ 473 w 3392"/>
                      <a:gd name="T3" fmla="*/ 3248 h 3392"/>
                      <a:gd name="T4" fmla="*/ 936 w 3392"/>
                      <a:gd name="T5" fmla="*/ 3251 h 3392"/>
                      <a:gd name="T6" fmla="*/ 1691 w 3392"/>
                      <a:gd name="T7" fmla="*/ 2508 h 3392"/>
                      <a:gd name="T8" fmla="*/ 2434 w 3392"/>
                      <a:gd name="T9" fmla="*/ 3262 h 3392"/>
                      <a:gd name="T10" fmla="*/ 2898 w 3392"/>
                      <a:gd name="T11" fmla="*/ 3265 h 3392"/>
                      <a:gd name="T12" fmla="*/ 3248 w 3392"/>
                      <a:gd name="T13" fmla="*/ 2920 h 3392"/>
                      <a:gd name="T14" fmla="*/ 3251 w 3392"/>
                      <a:gd name="T15" fmla="*/ 2456 h 3392"/>
                      <a:gd name="T16" fmla="*/ 2508 w 3392"/>
                      <a:gd name="T17" fmla="*/ 1702 h 3392"/>
                      <a:gd name="T18" fmla="*/ 3262 w 3392"/>
                      <a:gd name="T19" fmla="*/ 959 h 3392"/>
                      <a:gd name="T20" fmla="*/ 3265 w 3392"/>
                      <a:gd name="T21" fmla="*/ 495 h 3392"/>
                      <a:gd name="T22" fmla="*/ 2920 w 3392"/>
                      <a:gd name="T23" fmla="*/ 145 h 3392"/>
                      <a:gd name="T24" fmla="*/ 2456 w 3392"/>
                      <a:gd name="T25" fmla="*/ 141 h 3392"/>
                      <a:gd name="T26" fmla="*/ 1702 w 3392"/>
                      <a:gd name="T27" fmla="*/ 885 h 3392"/>
                      <a:gd name="T28" fmla="*/ 959 w 3392"/>
                      <a:gd name="T29" fmla="*/ 131 h 3392"/>
                      <a:gd name="T30" fmla="*/ 495 w 3392"/>
                      <a:gd name="T31" fmla="*/ 127 h 3392"/>
                      <a:gd name="T32" fmla="*/ 145 w 3392"/>
                      <a:gd name="T33" fmla="*/ 473 h 3392"/>
                      <a:gd name="T34" fmla="*/ 141 w 3392"/>
                      <a:gd name="T35" fmla="*/ 936 h 3392"/>
                      <a:gd name="T36" fmla="*/ 885 w 3392"/>
                      <a:gd name="T37" fmla="*/ 1690 h 3392"/>
                      <a:gd name="T38" fmla="*/ 131 w 3392"/>
                      <a:gd name="T39" fmla="*/ 2434 h 3392"/>
                      <a:gd name="T40" fmla="*/ 127 w 3392"/>
                      <a:gd name="T41" fmla="*/ 2898 h 339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</a:cxnLst>
                    <a:rect l="0" t="0" r="r" b="b"/>
                    <a:pathLst>
                      <a:path w="3392" h="3392">
                        <a:moveTo>
                          <a:pt x="127" y="2898"/>
                        </a:moveTo>
                        <a:lnTo>
                          <a:pt x="473" y="3248"/>
                        </a:lnTo>
                        <a:cubicBezTo>
                          <a:pt x="600" y="3377"/>
                          <a:pt x="808" y="3378"/>
                          <a:pt x="936" y="3251"/>
                        </a:cubicBezTo>
                        <a:lnTo>
                          <a:pt x="1691" y="2508"/>
                        </a:lnTo>
                        <a:lnTo>
                          <a:pt x="2434" y="3262"/>
                        </a:lnTo>
                        <a:cubicBezTo>
                          <a:pt x="2561" y="3391"/>
                          <a:pt x="2769" y="3392"/>
                          <a:pt x="2898" y="3265"/>
                        </a:cubicBezTo>
                        <a:lnTo>
                          <a:pt x="3248" y="2920"/>
                        </a:lnTo>
                        <a:cubicBezTo>
                          <a:pt x="3377" y="2793"/>
                          <a:pt x="3378" y="2585"/>
                          <a:pt x="3251" y="2456"/>
                        </a:cubicBezTo>
                        <a:lnTo>
                          <a:pt x="2508" y="1702"/>
                        </a:lnTo>
                        <a:lnTo>
                          <a:pt x="3262" y="959"/>
                        </a:lnTo>
                        <a:cubicBezTo>
                          <a:pt x="3391" y="832"/>
                          <a:pt x="3392" y="624"/>
                          <a:pt x="3265" y="495"/>
                        </a:cubicBezTo>
                        <a:lnTo>
                          <a:pt x="2920" y="145"/>
                        </a:lnTo>
                        <a:cubicBezTo>
                          <a:pt x="2793" y="16"/>
                          <a:pt x="2585" y="14"/>
                          <a:pt x="2456" y="141"/>
                        </a:cubicBezTo>
                        <a:lnTo>
                          <a:pt x="1702" y="885"/>
                        </a:lnTo>
                        <a:lnTo>
                          <a:pt x="959" y="131"/>
                        </a:lnTo>
                        <a:cubicBezTo>
                          <a:pt x="832" y="2"/>
                          <a:pt x="624" y="0"/>
                          <a:pt x="495" y="127"/>
                        </a:cubicBezTo>
                        <a:lnTo>
                          <a:pt x="145" y="473"/>
                        </a:lnTo>
                        <a:cubicBezTo>
                          <a:pt x="16" y="600"/>
                          <a:pt x="14" y="807"/>
                          <a:pt x="141" y="936"/>
                        </a:cubicBezTo>
                        <a:lnTo>
                          <a:pt x="885" y="1690"/>
                        </a:lnTo>
                        <a:lnTo>
                          <a:pt x="131" y="2434"/>
                        </a:lnTo>
                        <a:cubicBezTo>
                          <a:pt x="2" y="2561"/>
                          <a:pt x="0" y="2769"/>
                          <a:pt x="127" y="2898"/>
                        </a:cubicBezTo>
                        <a:close/>
                      </a:path>
                    </a:pathLst>
                  </a:custGeom>
                  <a:noFill/>
                  <a:ln w="28575">
                    <a:solidFill>
                      <a:srgbClr val="F43CCD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18" name="直接箭头连接符 17"/>
                  <p:cNvCxnSpPr/>
                  <p:nvPr/>
                </p:nvCxnSpPr>
                <p:spPr>
                  <a:xfrm flipH="1" flipV="1">
                    <a:off x="3952818" y="3711388"/>
                    <a:ext cx="32273" cy="311973"/>
                  </a:xfrm>
                  <a:prstGeom prst="straightConnector1">
                    <a:avLst/>
                  </a:prstGeom>
                  <a:ln w="28575">
                    <a:solidFill>
                      <a:srgbClr val="DECDFD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文本框 18"/>
                  <p:cNvSpPr txBox="1"/>
                  <p:nvPr/>
                </p:nvSpPr>
                <p:spPr>
                  <a:xfrm rot="21330699">
                    <a:off x="3920994" y="3620587"/>
                    <a:ext cx="1558232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b="1" dirty="0">
                        <a:latin typeface="MV Boli" panose="02000500030200090000" pitchFamily="2" charset="0"/>
                        <a:cs typeface="MV Boli" panose="02000500030200090000" pitchFamily="2" charset="0"/>
                      </a:rPr>
                      <a:t>interaction</a:t>
                    </a:r>
                    <a:endParaRPr lang="zh-CN" altLang="en-US" sz="2000" b="1" dirty="0">
                      <a:latin typeface="MV Boli" panose="02000500030200090000" pitchFamily="2" charset="0"/>
                      <a:cs typeface="MV Boli" panose="02000500030200090000" pitchFamily="2" charset="0"/>
                    </a:endParaRPr>
                  </a:p>
                </p:txBody>
              </p:sp>
            </p:grpSp>
            <p:grpSp>
              <p:nvGrpSpPr>
                <p:cNvPr id="54" name="组合 53"/>
                <p:cNvGrpSpPr/>
                <p:nvPr/>
              </p:nvGrpSpPr>
              <p:grpSpPr>
                <a:xfrm rot="12995928">
                  <a:off x="2926317" y="4378693"/>
                  <a:ext cx="518706" cy="465301"/>
                  <a:chOff x="1654644" y="4512235"/>
                  <a:chExt cx="518706" cy="465301"/>
                </a:xfrm>
              </p:grpSpPr>
              <p:sp>
                <p:nvSpPr>
                  <p:cNvPr id="55" name="椭圆 54"/>
                  <p:cNvSpPr/>
                  <p:nvPr/>
                </p:nvSpPr>
                <p:spPr>
                  <a:xfrm>
                    <a:off x="1654644" y="4759268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6" name="椭圆 55"/>
                  <p:cNvSpPr/>
                  <p:nvPr/>
                </p:nvSpPr>
                <p:spPr>
                  <a:xfrm>
                    <a:off x="1967146" y="4512235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7" name="椭圆 56"/>
                  <p:cNvSpPr/>
                  <p:nvPr/>
                </p:nvSpPr>
                <p:spPr>
                  <a:xfrm>
                    <a:off x="1859709" y="4718127"/>
                    <a:ext cx="238732" cy="250145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8" name="组合 57"/>
                <p:cNvGrpSpPr/>
                <p:nvPr/>
              </p:nvGrpSpPr>
              <p:grpSpPr>
                <a:xfrm rot="15024286">
                  <a:off x="2215862" y="4260963"/>
                  <a:ext cx="518706" cy="465301"/>
                  <a:chOff x="1654644" y="4512235"/>
                  <a:chExt cx="518706" cy="465301"/>
                </a:xfrm>
              </p:grpSpPr>
              <p:sp>
                <p:nvSpPr>
                  <p:cNvPr id="59" name="椭圆 58"/>
                  <p:cNvSpPr/>
                  <p:nvPr/>
                </p:nvSpPr>
                <p:spPr>
                  <a:xfrm>
                    <a:off x="1654644" y="4759268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0" name="椭圆 59"/>
                  <p:cNvSpPr/>
                  <p:nvPr/>
                </p:nvSpPr>
                <p:spPr>
                  <a:xfrm>
                    <a:off x="1967146" y="4512235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1" name="椭圆 60"/>
                  <p:cNvSpPr/>
                  <p:nvPr/>
                </p:nvSpPr>
                <p:spPr>
                  <a:xfrm>
                    <a:off x="1859709" y="4718127"/>
                    <a:ext cx="238732" cy="250145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2" name="组合 61"/>
                <p:cNvGrpSpPr/>
                <p:nvPr/>
              </p:nvGrpSpPr>
              <p:grpSpPr>
                <a:xfrm rot="12387825">
                  <a:off x="3725085" y="4262265"/>
                  <a:ext cx="518706" cy="465301"/>
                  <a:chOff x="1654644" y="4512235"/>
                  <a:chExt cx="518706" cy="465301"/>
                </a:xfrm>
              </p:grpSpPr>
              <p:sp>
                <p:nvSpPr>
                  <p:cNvPr id="63" name="椭圆 62"/>
                  <p:cNvSpPr/>
                  <p:nvPr/>
                </p:nvSpPr>
                <p:spPr>
                  <a:xfrm>
                    <a:off x="1654644" y="4759268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4" name="椭圆 63"/>
                  <p:cNvSpPr/>
                  <p:nvPr/>
                </p:nvSpPr>
                <p:spPr>
                  <a:xfrm>
                    <a:off x="1967146" y="4512235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5" name="椭圆 64"/>
                  <p:cNvSpPr/>
                  <p:nvPr/>
                </p:nvSpPr>
                <p:spPr>
                  <a:xfrm>
                    <a:off x="1859709" y="4718127"/>
                    <a:ext cx="238732" cy="250145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6" name="组合 65"/>
                <p:cNvGrpSpPr/>
                <p:nvPr/>
              </p:nvGrpSpPr>
              <p:grpSpPr>
                <a:xfrm rot="15745832">
                  <a:off x="1538882" y="3739531"/>
                  <a:ext cx="518706" cy="465301"/>
                  <a:chOff x="1654644" y="4512235"/>
                  <a:chExt cx="518706" cy="465301"/>
                </a:xfrm>
              </p:grpSpPr>
              <p:sp>
                <p:nvSpPr>
                  <p:cNvPr id="67" name="椭圆 66"/>
                  <p:cNvSpPr/>
                  <p:nvPr/>
                </p:nvSpPr>
                <p:spPr>
                  <a:xfrm>
                    <a:off x="1654644" y="4759268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8" name="椭圆 67"/>
                  <p:cNvSpPr/>
                  <p:nvPr/>
                </p:nvSpPr>
                <p:spPr>
                  <a:xfrm>
                    <a:off x="1967146" y="4512235"/>
                    <a:ext cx="206204" cy="218268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9" name="椭圆 68"/>
                  <p:cNvSpPr/>
                  <p:nvPr/>
                </p:nvSpPr>
                <p:spPr>
                  <a:xfrm>
                    <a:off x="1859709" y="4718127"/>
                    <a:ext cx="238732" cy="250145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  <a:scene3d>
                    <a:camera prst="orthographicFront">
                      <a:rot lat="0" lon="0" rev="0"/>
                    </a:camera>
                    <a:lightRig rig="threePt" dir="t"/>
                  </a:scene3d>
                  <a:sp3d>
                    <a:bevelT w="180000" h="180000"/>
                    <a:bevelB w="180000" h="180000"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52" name="文本框 51"/>
                <p:cNvSpPr txBox="1"/>
                <p:nvPr/>
              </p:nvSpPr>
              <p:spPr>
                <a:xfrm>
                  <a:off x="3767828" y="4235230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Si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94" name="文本框 93"/>
                <p:cNvSpPr txBox="1"/>
                <p:nvPr/>
              </p:nvSpPr>
              <p:spPr>
                <a:xfrm>
                  <a:off x="2320737" y="4269694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Si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95" name="文本框 94"/>
                <p:cNvSpPr txBox="1"/>
                <p:nvPr/>
              </p:nvSpPr>
              <p:spPr>
                <a:xfrm>
                  <a:off x="2978257" y="4366693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Si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96" name="文本框 95"/>
                <p:cNvSpPr txBox="1"/>
                <p:nvPr/>
              </p:nvSpPr>
              <p:spPr>
                <a:xfrm>
                  <a:off x="1682184" y="3762626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Si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cxnSp>
              <p:nvCxnSpPr>
                <p:cNvPr id="97" name="直接箭头连接符 96"/>
                <p:cNvCxnSpPr/>
                <p:nvPr/>
              </p:nvCxnSpPr>
              <p:spPr>
                <a:xfrm flipV="1">
                  <a:off x="3195021" y="4206241"/>
                  <a:ext cx="172123" cy="204394"/>
                </a:xfrm>
                <a:prstGeom prst="straightConnector1">
                  <a:avLst/>
                </a:prstGeom>
                <a:ln w="28575">
                  <a:solidFill>
                    <a:srgbClr val="DECDFD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文本框 98"/>
                <p:cNvSpPr txBox="1"/>
                <p:nvPr/>
              </p:nvSpPr>
              <p:spPr>
                <a:xfrm>
                  <a:off x="2740432" y="4129950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cxnSp>
              <p:nvCxnSpPr>
                <p:cNvPr id="107" name="直接箭头连接符 106"/>
                <p:cNvCxnSpPr/>
                <p:nvPr/>
              </p:nvCxnSpPr>
              <p:spPr>
                <a:xfrm flipV="1">
                  <a:off x="2583192" y="4254766"/>
                  <a:ext cx="225648" cy="133749"/>
                </a:xfrm>
                <a:prstGeom prst="straightConnector1">
                  <a:avLst/>
                </a:prstGeom>
                <a:ln w="28575">
                  <a:solidFill>
                    <a:srgbClr val="DECDFD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直接箭头连接符 108"/>
                <p:cNvCxnSpPr/>
                <p:nvPr/>
              </p:nvCxnSpPr>
              <p:spPr>
                <a:xfrm flipV="1">
                  <a:off x="1938738" y="3700631"/>
                  <a:ext cx="363398" cy="153473"/>
                </a:xfrm>
                <a:prstGeom prst="straightConnector1">
                  <a:avLst/>
                </a:prstGeom>
                <a:ln w="28575">
                  <a:solidFill>
                    <a:srgbClr val="DECDFD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椭圆 110"/>
                <p:cNvSpPr/>
                <p:nvPr/>
              </p:nvSpPr>
              <p:spPr>
                <a:xfrm>
                  <a:off x="4418733" y="2403266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2" name="椭圆 111"/>
                <p:cNvSpPr/>
                <p:nvPr/>
              </p:nvSpPr>
              <p:spPr>
                <a:xfrm>
                  <a:off x="4245941" y="2184647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3" name="椭圆 112"/>
                <p:cNvSpPr/>
                <p:nvPr/>
              </p:nvSpPr>
              <p:spPr>
                <a:xfrm>
                  <a:off x="7618228" y="2474454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4" name="椭圆 113"/>
                <p:cNvSpPr/>
                <p:nvPr/>
              </p:nvSpPr>
              <p:spPr>
                <a:xfrm>
                  <a:off x="7882755" y="2295279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5" name="椭圆 114"/>
                <p:cNvSpPr/>
                <p:nvPr/>
              </p:nvSpPr>
              <p:spPr>
                <a:xfrm>
                  <a:off x="7882755" y="2550683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6" name="椭圆 115"/>
                <p:cNvSpPr/>
                <p:nvPr/>
              </p:nvSpPr>
              <p:spPr>
                <a:xfrm>
                  <a:off x="7602478" y="3893271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3" name="文本框 122"/>
                <p:cNvSpPr txBox="1"/>
                <p:nvPr/>
              </p:nvSpPr>
              <p:spPr>
                <a:xfrm>
                  <a:off x="1655212" y="1658658"/>
                  <a:ext cx="343017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dirty="0">
                      <a:latin typeface="MV Boli" panose="02000500030200090000" pitchFamily="2" charset="0"/>
                      <a:cs typeface="MV Boli" panose="02000500030200090000" pitchFamily="2" charset="0"/>
                    </a:rPr>
                    <a:t>w</a:t>
                  </a:r>
                  <a:r>
                    <a:rPr lang="en-US" altLang="zh-CN" sz="20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ithout </a:t>
                  </a:r>
                  <a:r>
                    <a:rPr lang="en-US" altLang="zh-CN" sz="2000" dirty="0">
                      <a:latin typeface="MV Boli" panose="02000500030200090000" pitchFamily="2" charset="0"/>
                      <a:cs typeface="MV Boli" panose="02000500030200090000" pitchFamily="2" charset="0"/>
                    </a:rPr>
                    <a:t>silica protection</a:t>
                  </a:r>
                  <a:endParaRPr lang="zh-CN" altLang="en-US" sz="20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25" name="文本框 124"/>
                <p:cNvSpPr txBox="1"/>
                <p:nvPr/>
              </p:nvSpPr>
              <p:spPr>
                <a:xfrm>
                  <a:off x="1647149" y="4717133"/>
                  <a:ext cx="343017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dirty="0">
                      <a:latin typeface="MV Boli" panose="02000500030200090000" pitchFamily="2" charset="0"/>
                      <a:cs typeface="MV Boli" panose="02000500030200090000" pitchFamily="2" charset="0"/>
                    </a:rPr>
                    <a:t>surface silica protection</a:t>
                  </a:r>
                  <a:endParaRPr lang="zh-CN" altLang="en-US" sz="20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26" name="椭圆 125"/>
                <p:cNvSpPr/>
                <p:nvPr/>
              </p:nvSpPr>
              <p:spPr>
                <a:xfrm>
                  <a:off x="2678717" y="5399865"/>
                  <a:ext cx="206204" cy="218268"/>
                </a:xfrm>
                <a:prstGeom prst="ellipse">
                  <a:avLst/>
                </a:prstGeom>
                <a:solidFill>
                  <a:srgbClr val="99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7" name="椭圆 126"/>
                <p:cNvSpPr/>
                <p:nvPr/>
              </p:nvSpPr>
              <p:spPr>
                <a:xfrm>
                  <a:off x="1821684" y="5399865"/>
                  <a:ext cx="206204" cy="218268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8" name="椭圆 127"/>
                <p:cNvSpPr/>
                <p:nvPr/>
              </p:nvSpPr>
              <p:spPr>
                <a:xfrm>
                  <a:off x="2092639" y="5399865"/>
                  <a:ext cx="206204" cy="218268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9" name="椭圆 128"/>
                <p:cNvSpPr/>
                <p:nvPr/>
              </p:nvSpPr>
              <p:spPr>
                <a:xfrm>
                  <a:off x="2367655" y="5399865"/>
                  <a:ext cx="206204" cy="218268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noFill/>
                </a:ln>
                <a:scene3d>
                  <a:camera prst="orthographicFront">
                    <a:rot lat="0" lon="0" rev="0"/>
                  </a:camera>
                  <a:lightRig rig="threePt" dir="t"/>
                </a:scene3d>
                <a:sp3d>
                  <a:bevelT w="180000" h="180000"/>
                  <a:bevelB w="180000" h="1800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0" name="文本框 129"/>
                <p:cNvSpPr txBox="1"/>
                <p:nvPr/>
              </p:nvSpPr>
              <p:spPr>
                <a:xfrm>
                  <a:off x="2603527" y="5354431"/>
                  <a:ext cx="296893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 of metallic </a:t>
                  </a:r>
                  <a:r>
                    <a:rPr lang="en-US" altLang="zh-CN" sz="1600" dirty="0">
                      <a:latin typeface="MV Boli" panose="02000500030200090000" pitchFamily="2" charset="0"/>
                      <a:cs typeface="MV Boli" panose="02000500030200090000" pitchFamily="2" charset="0"/>
                    </a:rPr>
                    <a:t>indium species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2" name="文本框 131"/>
                <p:cNvSpPr txBox="1"/>
                <p:nvPr/>
              </p:nvSpPr>
              <p:spPr>
                <a:xfrm>
                  <a:off x="1721832" y="5362321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MV Boli" panose="02000500030200090000" pitchFamily="2" charset="0"/>
                      <a:cs typeface="MV Boli" panose="02000500030200090000" pitchFamily="2" charset="0"/>
                    </a:rPr>
                    <a:t>Si</a:t>
                  </a:r>
                  <a:endParaRPr lang="zh-CN" altLang="en-US" sz="1600" dirty="0"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3" name="文本框 132"/>
                <p:cNvSpPr txBox="1"/>
                <p:nvPr/>
              </p:nvSpPr>
              <p:spPr>
                <a:xfrm>
                  <a:off x="2012318" y="5365731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O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4" name="文本框 133"/>
                <p:cNvSpPr txBox="1"/>
                <p:nvPr/>
              </p:nvSpPr>
              <p:spPr>
                <a:xfrm>
                  <a:off x="2250779" y="5356766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Zr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5" name="文本框 134"/>
                <p:cNvSpPr txBox="1"/>
                <p:nvPr/>
              </p:nvSpPr>
              <p:spPr>
                <a:xfrm>
                  <a:off x="4150907" y="2146493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6" name="文本框 135"/>
                <p:cNvSpPr txBox="1"/>
                <p:nvPr/>
              </p:nvSpPr>
              <p:spPr>
                <a:xfrm>
                  <a:off x="4323030" y="2350889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7" name="文本框 136"/>
                <p:cNvSpPr txBox="1"/>
                <p:nvPr/>
              </p:nvSpPr>
              <p:spPr>
                <a:xfrm>
                  <a:off x="4507703" y="2600108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8" name="文本框 137"/>
                <p:cNvSpPr txBox="1"/>
                <p:nvPr/>
              </p:nvSpPr>
              <p:spPr>
                <a:xfrm>
                  <a:off x="7532395" y="2429779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39" name="文本框 138"/>
                <p:cNvSpPr txBox="1"/>
                <p:nvPr/>
              </p:nvSpPr>
              <p:spPr>
                <a:xfrm>
                  <a:off x="7803129" y="2259449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40" name="文本框 139"/>
                <p:cNvSpPr txBox="1"/>
                <p:nvPr/>
              </p:nvSpPr>
              <p:spPr>
                <a:xfrm>
                  <a:off x="7794164" y="2519425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  <p:sp>
              <p:nvSpPr>
                <p:cNvPr id="141" name="文本框 140"/>
                <p:cNvSpPr txBox="1"/>
                <p:nvPr/>
              </p:nvSpPr>
              <p:spPr>
                <a:xfrm>
                  <a:off x="7516258" y="3844409"/>
                  <a:ext cx="5641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solidFill>
                        <a:schemeClr val="bg1"/>
                      </a:solidFill>
                      <a:latin typeface="MV Boli" panose="02000500030200090000" pitchFamily="2" charset="0"/>
                      <a:cs typeface="MV Boli" panose="02000500030200090000" pitchFamily="2" charset="0"/>
                    </a:rPr>
                    <a:t>In</a:t>
                  </a:r>
                  <a:endParaRPr lang="zh-CN" altLang="en-US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endParaRPr>
                </a:p>
              </p:txBody>
            </p:sp>
          </p:grpSp>
          <p:sp>
            <p:nvSpPr>
              <p:cNvPr id="70" name="椭圆 69"/>
              <p:cNvSpPr/>
              <p:nvPr/>
            </p:nvSpPr>
            <p:spPr>
              <a:xfrm rot="15745832">
                <a:off x="5512259" y="5401997"/>
                <a:ext cx="206204" cy="218268"/>
              </a:xfrm>
              <a:prstGeom prst="ellipse">
                <a:avLst/>
              </a:prstGeom>
              <a:solidFill>
                <a:srgbClr val="99330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  <a:sp3d>
                <a:bevelT w="180000" h="180000"/>
                <a:bevelB w="180000" h="1800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5431591" y="5365560"/>
                <a:ext cx="185887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solidFill>
                      <a:schemeClr val="bg1"/>
                    </a:solidFill>
                    <a:latin typeface="MV Boli" panose="02000500030200090000" pitchFamily="2" charset="0"/>
                    <a:cs typeface="MV Boli" panose="02000500030200090000" pitchFamily="2" charset="0"/>
                  </a:rPr>
                  <a:t>In </a:t>
                </a:r>
                <a:r>
                  <a:rPr lang="en-US" altLang="zh-CN" sz="1600" dirty="0" smtClean="0">
                    <a:latin typeface="MV Boli" panose="02000500030200090000" pitchFamily="2" charset="0"/>
                    <a:cs typeface="MV Boli" panose="02000500030200090000" pitchFamily="2" charset="0"/>
                  </a:rPr>
                  <a:t>of In</a:t>
                </a:r>
                <a:r>
                  <a:rPr lang="en-US" altLang="zh-CN" sz="1600" baseline="-25000" dirty="0" smtClean="0">
                    <a:latin typeface="MV Boli" panose="02000500030200090000" pitchFamily="2" charset="0"/>
                    <a:cs typeface="MV Boli" panose="02000500030200090000" pitchFamily="2" charset="0"/>
                  </a:rPr>
                  <a:t>2</a:t>
                </a:r>
                <a:r>
                  <a:rPr lang="en-US" altLang="zh-CN" sz="1600" dirty="0" smtClean="0">
                    <a:latin typeface="MV Boli" panose="02000500030200090000" pitchFamily="2" charset="0"/>
                    <a:cs typeface="MV Boli" panose="02000500030200090000" pitchFamily="2" charset="0"/>
                  </a:rPr>
                  <a:t>O</a:t>
                </a:r>
                <a:r>
                  <a:rPr lang="en-US" altLang="zh-CN" sz="1600" baseline="-25000" dirty="0" smtClean="0">
                    <a:latin typeface="MV Boli" panose="02000500030200090000" pitchFamily="2" charset="0"/>
                    <a:cs typeface="MV Boli" panose="02000500030200090000" pitchFamily="2" charset="0"/>
                  </a:rPr>
                  <a:t>3</a:t>
                </a:r>
                <a:endParaRPr lang="zh-CN" altLang="en-US" sz="1600" baseline="-25000" dirty="0">
                  <a:latin typeface="MV Boli" panose="02000500030200090000" pitchFamily="2" charset="0"/>
                  <a:cs typeface="MV Boli" panose="02000500030200090000" pitchFamily="2" charset="0"/>
                </a:endParaRPr>
              </a:p>
            </p:txBody>
          </p:sp>
        </p:grpSp>
        <p:sp>
          <p:nvSpPr>
            <p:cNvPr id="72" name="文本框 71"/>
            <p:cNvSpPr txBox="1"/>
            <p:nvPr/>
          </p:nvSpPr>
          <p:spPr>
            <a:xfrm>
              <a:off x="1275156" y="732065"/>
              <a:ext cx="66697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53291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宽屏</PresentationFormat>
  <Paragraphs>28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MV Boli</vt:lpstr>
      <vt:lpstr>Office 主题​​</vt:lpstr>
      <vt:lpstr>CS ChemDraw Drawing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23-04-25T00:52:52Z</dcterms:created>
  <dcterms:modified xsi:type="dcterms:W3CDTF">2023-04-25T00:53:11Z</dcterms:modified>
</cp:coreProperties>
</file>